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wdp" ContentType="image/vnd.ms-photo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notesMasterIdLst>
    <p:notesMasterId r:id="rId3"/>
  </p:notesMasterIdLst>
  <p:sldIdLst>
    <p:sldId id="257" r:id="rId2"/>
  </p:sldIdLst>
  <p:sldSz cx="9144000" cy="1296035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941"/>
    <p:restoredTop sz="94729"/>
  </p:normalViewPr>
  <p:slideViewPr>
    <p:cSldViewPr snapToGrid="0" snapToObjects="1">
      <p:cViewPr>
        <p:scale>
          <a:sx n="98" d="100"/>
          <a:sy n="98" d="100"/>
        </p:scale>
        <p:origin x="-3200" y="-576"/>
      </p:cViewPr>
      <p:guideLst>
        <p:guide orient="horz" pos="4082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9209523-C33E-0244-979B-DC146A24017E}" type="datetimeFigureOut">
              <a:rPr kumimoji="1" lang="zh-CN" altLang="en-US" smtClean="0"/>
              <a:t>19/5/15</a:t>
            </a:fld>
            <a:endParaRPr kumimoji="1"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39975" y="1143000"/>
            <a:ext cx="21780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A0C2757-7954-6247-BC95-988200620EA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093674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21058"/>
            <a:ext cx="7772400" cy="4512122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6807185"/>
            <a:ext cx="6858000" cy="3129084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88F211-E76E-9C47-B7FA-4A3067FE53A3}" type="datetimeFigureOut">
              <a:rPr kumimoji="1" lang="zh-CN" altLang="en-US" smtClean="0"/>
              <a:t>19/5/15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29EBC-94BB-1A42-9C54-92F7C9C24441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88F211-E76E-9C47-B7FA-4A3067FE53A3}" type="datetimeFigureOut">
              <a:rPr kumimoji="1" lang="zh-CN" altLang="en-US" smtClean="0"/>
              <a:t>19/5/15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29EBC-94BB-1A42-9C54-92F7C9C24441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690018"/>
            <a:ext cx="1971675" cy="1098329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690018"/>
            <a:ext cx="5800725" cy="1098329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88F211-E76E-9C47-B7FA-4A3067FE53A3}" type="datetimeFigureOut">
              <a:rPr kumimoji="1" lang="zh-CN" altLang="en-US" smtClean="0"/>
              <a:t>19/5/15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29EBC-94BB-1A42-9C54-92F7C9C24441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88F211-E76E-9C47-B7FA-4A3067FE53A3}" type="datetimeFigureOut">
              <a:rPr kumimoji="1" lang="zh-CN" altLang="en-US" smtClean="0"/>
              <a:t>19/5/15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29EBC-94BB-1A42-9C54-92F7C9C24441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3231091"/>
            <a:ext cx="7886700" cy="5391145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8673238"/>
            <a:ext cx="7886700" cy="2835076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88F211-E76E-9C47-B7FA-4A3067FE53A3}" type="datetimeFigureOut">
              <a:rPr kumimoji="1" lang="zh-CN" altLang="en-US" smtClean="0"/>
              <a:t>19/5/15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29EBC-94BB-1A42-9C54-92F7C9C24441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3450093"/>
            <a:ext cx="3886200" cy="822322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3450093"/>
            <a:ext cx="3886200" cy="822322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88F211-E76E-9C47-B7FA-4A3067FE53A3}" type="datetimeFigureOut">
              <a:rPr kumimoji="1" lang="zh-CN" altLang="en-US" smtClean="0"/>
              <a:t>19/5/15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29EBC-94BB-1A42-9C54-92F7C9C24441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690021"/>
            <a:ext cx="7886700" cy="2505069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3177087"/>
            <a:ext cx="3868340" cy="155704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4734128"/>
            <a:ext cx="3868340" cy="6963189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3177087"/>
            <a:ext cx="3887391" cy="155704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4734128"/>
            <a:ext cx="3887391" cy="6963189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88F211-E76E-9C47-B7FA-4A3067FE53A3}" type="datetimeFigureOut">
              <a:rPr kumimoji="1" lang="zh-CN" altLang="en-US" smtClean="0"/>
              <a:t>19/5/15</a:t>
            </a:fld>
            <a:endParaRPr kumimoji="1"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29EBC-94BB-1A42-9C54-92F7C9C24441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88F211-E76E-9C47-B7FA-4A3067FE53A3}" type="datetimeFigureOut">
              <a:rPr kumimoji="1" lang="zh-CN" altLang="en-US" smtClean="0"/>
              <a:t>19/5/15</a:t>
            </a:fld>
            <a:endParaRPr kumimoji="1"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29EBC-94BB-1A42-9C54-92F7C9C24441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88F211-E76E-9C47-B7FA-4A3067FE53A3}" type="datetimeFigureOut">
              <a:rPr kumimoji="1" lang="zh-CN" altLang="en-US" smtClean="0"/>
              <a:t>19/5/15</a:t>
            </a:fld>
            <a:endParaRPr kumimoji="1"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29EBC-94BB-1A42-9C54-92F7C9C24441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864023"/>
            <a:ext cx="2949178" cy="3024082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1866053"/>
            <a:ext cx="4629150" cy="9210249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3888105"/>
            <a:ext cx="2949178" cy="7203195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88F211-E76E-9C47-B7FA-4A3067FE53A3}" type="datetimeFigureOut">
              <a:rPr kumimoji="1" lang="zh-CN" altLang="en-US" smtClean="0"/>
              <a:t>19/5/15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29EBC-94BB-1A42-9C54-92F7C9C24441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864023"/>
            <a:ext cx="2949178" cy="3024082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1866053"/>
            <a:ext cx="4629150" cy="9210249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 smtClean="0"/>
              <a:t>将图片拖动到占位符，或单击添加图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3888105"/>
            <a:ext cx="2949178" cy="7203195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88F211-E76E-9C47-B7FA-4A3067FE53A3}" type="datetimeFigureOut">
              <a:rPr kumimoji="1" lang="zh-CN" altLang="en-US" smtClean="0"/>
              <a:t>19/5/15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29EBC-94BB-1A42-9C54-92F7C9C24441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690021"/>
            <a:ext cx="7886700" cy="250506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3450093"/>
            <a:ext cx="7886700" cy="822322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12012327"/>
            <a:ext cx="2057400" cy="6900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88F211-E76E-9C47-B7FA-4A3067FE53A3}" type="datetimeFigureOut">
              <a:rPr kumimoji="1" lang="zh-CN" altLang="en-US" smtClean="0"/>
              <a:t>19/5/15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12012327"/>
            <a:ext cx="3086100" cy="6900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12012327"/>
            <a:ext cx="2057400" cy="6900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129EBC-94BB-1A42-9C54-92F7C9C24441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169490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Relationship Id="rId3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图片 15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68000"/>
                    </a14:imgEffect>
                    <a14:imgEffect>
                      <a14:brightnessContrast bright="10000" contrast="3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4669" t="64466" r="14347" b="5498"/>
          <a:stretch/>
        </p:blipFill>
        <p:spPr>
          <a:xfrm>
            <a:off x="2487486" y="2017768"/>
            <a:ext cx="2992484" cy="3182306"/>
          </a:xfrm>
          <a:prstGeom prst="rect">
            <a:avLst/>
          </a:prstGeom>
        </p:spPr>
      </p:pic>
      <p:cxnSp>
        <p:nvCxnSpPr>
          <p:cNvPr id="18" name="直线连接符 17"/>
          <p:cNvCxnSpPr/>
          <p:nvPr/>
        </p:nvCxnSpPr>
        <p:spPr>
          <a:xfrm>
            <a:off x="3931920" y="4979060"/>
            <a:ext cx="152192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文本框 1"/>
          <p:cNvSpPr txBox="1"/>
          <p:nvPr/>
        </p:nvSpPr>
        <p:spPr>
          <a:xfrm>
            <a:off x="483325" y="5656218"/>
            <a:ext cx="82421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Supplemental Figure S1. </a:t>
            </a:r>
            <a:r>
              <a:rPr lang="en-US" altLang="zh-CN" dirty="0"/>
              <a:t>Electron microscope image of a purified </a:t>
            </a:r>
            <a:r>
              <a:rPr lang="en-US" altLang="zh-CN" dirty="0" err="1"/>
              <a:t>PDCoV</a:t>
            </a:r>
            <a:r>
              <a:rPr lang="en-US" altLang="zh-CN" dirty="0"/>
              <a:t> particle using </a:t>
            </a:r>
            <a:r>
              <a:rPr lang="en-US" altLang="zh-CN" dirty="0" err="1"/>
              <a:t>phosphotungstic</a:t>
            </a:r>
            <a:r>
              <a:rPr lang="en-US" altLang="zh-CN" dirty="0"/>
              <a:t> acid negative staining. </a:t>
            </a:r>
            <a:r>
              <a:rPr lang="en-US" altLang="zh-CN" dirty="0" smtClean="0"/>
              <a:t>Bar </a:t>
            </a:r>
            <a:r>
              <a:rPr lang="en-US" altLang="zh-CN" dirty="0"/>
              <a:t>= 100 nm. </a:t>
            </a:r>
            <a:endParaRPr lang="zh-CN" altLang="zh-CN" dirty="0"/>
          </a:p>
          <a:p>
            <a:endParaRPr kumimoji="1"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9062918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DengXian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DengXian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87</TotalTime>
  <Words>23</Words>
  <Application>Microsoft Macintosh PowerPoint</Application>
  <PresentationFormat>自定义</PresentationFormat>
  <Paragraphs>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crosoft Office 用户</dc:creator>
  <cp:lastModifiedBy>Yaowei Huang</cp:lastModifiedBy>
  <cp:revision>28</cp:revision>
  <cp:lastPrinted>2019-02-16T07:13:25Z</cp:lastPrinted>
  <dcterms:created xsi:type="dcterms:W3CDTF">2019-02-15T09:13:37Z</dcterms:created>
  <dcterms:modified xsi:type="dcterms:W3CDTF">2019-05-15T04:13:43Z</dcterms:modified>
</cp:coreProperties>
</file>